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759450" cy="8999538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BE0C71-CC73-4EE4-9C98-4826B3CB03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86920" y="360000"/>
            <a:ext cx="5186520" cy="150012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86920" y="2099880"/>
            <a:ext cx="518652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86920" y="5202720"/>
            <a:ext cx="518652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928B2E-4EB0-466E-B749-1846B5C55F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86920" y="360000"/>
            <a:ext cx="5186520" cy="150012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86920" y="2099880"/>
            <a:ext cx="253080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944800" y="2099880"/>
            <a:ext cx="253080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86920" y="5202720"/>
            <a:ext cx="253080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944800" y="5202720"/>
            <a:ext cx="253080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2584D-6F65-4CA3-9D49-4F23868166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86920" y="360000"/>
            <a:ext cx="5186520" cy="150012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86920" y="2099880"/>
            <a:ext cx="166968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040480" y="2099880"/>
            <a:ext cx="166968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794040" y="2099880"/>
            <a:ext cx="166968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86920" y="5202720"/>
            <a:ext cx="166968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040480" y="5202720"/>
            <a:ext cx="166968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794040" y="5202720"/>
            <a:ext cx="166968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CACE8-C56D-4D5E-A437-6AE20A216E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86920" y="360000"/>
            <a:ext cx="5186520" cy="150012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86920" y="2099880"/>
            <a:ext cx="5186520" cy="594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460181-AFDF-4EAE-ADE5-532BC99FB7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86920" y="360000"/>
            <a:ext cx="5186520" cy="150012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86920" y="2099880"/>
            <a:ext cx="5186520" cy="594036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73DEF-9947-4A78-8477-BF21B4AA04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86920" y="360000"/>
            <a:ext cx="5186520" cy="150012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86920" y="2099880"/>
            <a:ext cx="2530800" cy="594036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944800" y="2099880"/>
            <a:ext cx="2530800" cy="594036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EBD050-4B26-4F24-A03A-EBC3C28EBC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86920" y="360000"/>
            <a:ext cx="5186520" cy="150012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248B0D-8986-4D73-A1AE-286937400B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86920" y="360000"/>
            <a:ext cx="5186520" cy="6954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EB8F6-892D-486C-B960-28D0242D92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86920" y="360000"/>
            <a:ext cx="5186520" cy="150012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86920" y="2099880"/>
            <a:ext cx="253080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944800" y="2099880"/>
            <a:ext cx="2530800" cy="594036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86920" y="5202720"/>
            <a:ext cx="253080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B5839-76EC-49D6-8C97-A31143DAE7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86920" y="360000"/>
            <a:ext cx="5186520" cy="150012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86920" y="2099880"/>
            <a:ext cx="2530800" cy="594036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944800" y="2099880"/>
            <a:ext cx="253080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944800" y="5202720"/>
            <a:ext cx="253080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3D2587-5908-4416-8632-11AE7D999B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86920" y="360000"/>
            <a:ext cx="5186520" cy="150012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86920" y="2099880"/>
            <a:ext cx="253080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944800" y="2099880"/>
            <a:ext cx="253080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86920" y="5202720"/>
            <a:ext cx="5186520" cy="283320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92565-C233-442E-A71E-1F5C91A00E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86920" y="360000"/>
            <a:ext cx="5186520" cy="150012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ctr">
            <a:noAutofit/>
          </a:bodyPr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86920" y="2099880"/>
            <a:ext cx="5186520" cy="594036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rmAutofit/>
          </a:bodyPr>
          <a:p>
            <a:pPr marL="301680" indent="-30168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54120" indent="-25092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06560" indent="-2016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09760" indent="-2016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11160" indent="-201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11160" indent="-201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11160" indent="-2016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86920" y="8196120"/>
            <a:ext cx="1344600" cy="62568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Autofit/>
          </a:bodyPr>
          <a:lstStyle>
            <a:lvl1pPr indent="0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968120" y="8196120"/>
            <a:ext cx="1824120" cy="62568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Autofit/>
          </a:bodyPr>
          <a:lstStyle>
            <a:lvl1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128840" y="8196120"/>
            <a:ext cx="1344600" cy="625680"/>
          </a:xfrm>
          <a:prstGeom prst="rect">
            <a:avLst/>
          </a:prstGeom>
          <a:noFill/>
          <a:ln w="0">
            <a:noFill/>
          </a:ln>
        </p:spPr>
        <p:txBody>
          <a:bodyPr lIns="80640" rIns="80640" tIns="40320" bIns="40320" anchor="t">
            <a:noAutofit/>
          </a:bodyPr>
          <a:lstStyle>
            <a:lvl1pPr indent="0" algn="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804960"/>
                <a:tab algn="l" pos="1609560"/>
                <a:tab algn="l" pos="2414520"/>
                <a:tab algn="l" pos="3219480"/>
                <a:tab algn="l" pos="4024440"/>
                <a:tab algn="l" pos="4829040"/>
                <a:tab algn="l" pos="5634000"/>
                <a:tab algn="l" pos="6438960"/>
                <a:tab algn="l" pos="7243920"/>
                <a:tab algn="l" pos="8048520"/>
                <a:tab algn="l" pos="8853480"/>
                <a:tab algn="l" pos="9658440"/>
                <a:tab algn="l" pos="10463040"/>
              </a:tabLst>
            </a:pPr>
            <a:fld id="{A895E3B5-1F0F-4335-A1E3-7619A7EBDF5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58760" y="392040"/>
            <a:ext cx="5442120" cy="8219160"/>
            <a:chOff x="158760" y="392040"/>
            <a:chExt cx="5442120" cy="8219160"/>
          </a:xfrm>
        </p:grpSpPr>
        <p:sp>
          <p:nvSpPr>
            <p:cNvPr id="42" name=""/>
            <p:cNvSpPr/>
            <p:nvPr/>
          </p:nvSpPr>
          <p:spPr>
            <a:xfrm>
              <a:off x="780840" y="392040"/>
              <a:ext cx="1651320" cy="213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 Narrow"/>
                </a:rPr>
                <a:t>E3U-E4L primer pai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788760" y="5294160"/>
              <a:ext cx="32925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y = -3.180x + 33.652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	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r = 0.997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	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E = 1.0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780840" y="4857480"/>
              <a:ext cx="1651320" cy="2134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400" spc="-1" strike="noStrike">
                  <a:solidFill>
                    <a:srgbClr val="000000"/>
                  </a:solidFill>
                  <a:latin typeface="Arial Narrow"/>
                </a:rPr>
                <a:t>E3U-I3L primer pair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788760" y="752400"/>
              <a:ext cx="32925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y = -3.185x + 31.184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	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r = 0.996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	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 Narrow"/>
                </a:rPr>
                <a:t>E = 1.0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017440" y="3852720"/>
              <a:ext cx="22820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Arial Narrow"/>
                </a:rPr>
                <a:t>Log Starting Quantity, pg total RN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7" name=""/>
            <p:cNvGrpSpPr/>
            <p:nvPr/>
          </p:nvGrpSpPr>
          <p:grpSpPr>
            <a:xfrm>
              <a:off x="509400" y="5502240"/>
              <a:ext cx="5091480" cy="2838960"/>
              <a:chOff x="509400" y="5502240"/>
              <a:chExt cx="5091480" cy="2838960"/>
            </a:xfrm>
          </p:grpSpPr>
          <p:sp>
            <p:nvSpPr>
              <p:cNvPr id="48" name=""/>
              <p:cNvSpPr/>
              <p:nvPr/>
            </p:nvSpPr>
            <p:spPr>
              <a:xfrm>
                <a:off x="776160" y="7538760"/>
                <a:ext cx="4771800" cy="1080"/>
              </a:xfrm>
              <a:prstGeom prst="line">
                <a:avLst/>
              </a:prstGeom>
              <a:ln w="0">
                <a:solidFill>
                  <a:srgbClr val="c0c0c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776160" y="7059240"/>
                <a:ext cx="4771800" cy="1080"/>
              </a:xfrm>
              <a:prstGeom prst="line">
                <a:avLst/>
              </a:prstGeom>
              <a:ln w="0">
                <a:solidFill>
                  <a:srgbClr val="c0c0c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776160" y="6578280"/>
                <a:ext cx="4771800" cy="1080"/>
              </a:xfrm>
              <a:prstGeom prst="line">
                <a:avLst/>
              </a:prstGeom>
              <a:ln w="0">
                <a:solidFill>
                  <a:srgbClr val="c0c0c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776160" y="6098760"/>
                <a:ext cx="4771800" cy="1080"/>
              </a:xfrm>
              <a:prstGeom prst="line">
                <a:avLst/>
              </a:prstGeom>
              <a:ln w="0">
                <a:solidFill>
                  <a:srgbClr val="c0c0c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061640" y="6149520"/>
                <a:ext cx="3819600" cy="1218960"/>
              </a:xfrm>
              <a:custGeom>
                <a:avLst/>
                <a:gdLst/>
                <a:ahLst/>
                <a:rect l="l" t="t" r="r" b="b"/>
                <a:pathLst>
                  <a:path w="401" h="122">
                    <a:moveTo>
                      <a:pt x="0" y="0"/>
                    </a:moveTo>
                    <a:lnTo>
                      <a:pt x="21" y="6"/>
                    </a:lnTo>
                    <a:lnTo>
                      <a:pt x="42" y="13"/>
                    </a:lnTo>
                    <a:lnTo>
                      <a:pt x="63" y="19"/>
                    </a:lnTo>
                    <a:lnTo>
                      <a:pt x="85" y="25"/>
                    </a:lnTo>
                    <a:lnTo>
                      <a:pt x="106" y="32"/>
                    </a:lnTo>
                    <a:lnTo>
                      <a:pt x="127" y="38"/>
                    </a:lnTo>
                    <a:lnTo>
                      <a:pt x="148" y="45"/>
                    </a:lnTo>
                    <a:lnTo>
                      <a:pt x="169" y="51"/>
                    </a:lnTo>
                    <a:lnTo>
                      <a:pt x="190" y="57"/>
                    </a:lnTo>
                    <a:lnTo>
                      <a:pt x="211" y="64"/>
                    </a:lnTo>
                    <a:lnTo>
                      <a:pt x="232" y="70"/>
                    </a:lnTo>
                    <a:lnTo>
                      <a:pt x="253" y="77"/>
                    </a:lnTo>
                    <a:lnTo>
                      <a:pt x="274" y="83"/>
                    </a:lnTo>
                    <a:lnTo>
                      <a:pt x="295" y="90"/>
                    </a:lnTo>
                    <a:lnTo>
                      <a:pt x="317" y="96"/>
                    </a:lnTo>
                    <a:lnTo>
                      <a:pt x="338" y="102"/>
                    </a:lnTo>
                    <a:lnTo>
                      <a:pt x="359" y="109"/>
                    </a:lnTo>
                    <a:lnTo>
                      <a:pt x="380" y="115"/>
                    </a:lnTo>
                    <a:lnTo>
                      <a:pt x="401" y="122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776160" y="5619240"/>
                <a:ext cx="4771800" cy="1440"/>
              </a:xfrm>
              <a:prstGeom prst="line">
                <a:avLst/>
              </a:prstGeom>
              <a:ln w="0">
                <a:solidFill>
                  <a:srgbClr val="c0c0c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776160" y="5619240"/>
                <a:ext cx="4771800" cy="2398320"/>
              </a:xfrm>
              <a:prstGeom prst="rect">
                <a:avLst/>
              </a:prstGeom>
              <a:noFill/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776160" y="5619240"/>
                <a:ext cx="1440" cy="2398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738000" y="8017920"/>
                <a:ext cx="3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738000" y="7538760"/>
                <a:ext cx="381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738000" y="7059240"/>
                <a:ext cx="381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738000" y="6578280"/>
                <a:ext cx="381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738000" y="6098760"/>
                <a:ext cx="3816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738000" y="5619240"/>
                <a:ext cx="3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776160" y="8017920"/>
                <a:ext cx="477180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V="1">
                <a:off x="776160" y="8017920"/>
                <a:ext cx="144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 flipV="1">
                <a:off x="1728360" y="8017920"/>
                <a:ext cx="180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 flipV="1">
                <a:off x="2680920" y="8017920"/>
                <a:ext cx="180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 flipV="1">
                <a:off x="3643200" y="8017920"/>
                <a:ext cx="144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 flipV="1">
                <a:off x="4595400" y="8017920"/>
                <a:ext cx="180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V="1">
                <a:off x="5547960" y="8017920"/>
                <a:ext cx="1800" cy="39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4852800" y="7308360"/>
                <a:ext cx="47520" cy="489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4852800" y="7299000"/>
                <a:ext cx="47520" cy="489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4852800" y="7299000"/>
                <a:ext cx="47520" cy="489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4852800" y="7287840"/>
                <a:ext cx="47520" cy="504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3900240" y="7068600"/>
                <a:ext cx="47520" cy="489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3900240" y="7078320"/>
                <a:ext cx="47520" cy="504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3900240" y="7048080"/>
                <a:ext cx="47520" cy="504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3900240" y="7059240"/>
                <a:ext cx="47520" cy="489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947680" y="6738480"/>
                <a:ext cx="47520" cy="504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947680" y="6748200"/>
                <a:ext cx="47520" cy="504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2947680" y="6798960"/>
                <a:ext cx="47520" cy="48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947680" y="6759360"/>
                <a:ext cx="47520" cy="486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1985760" y="6399000"/>
                <a:ext cx="47520" cy="504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1985760" y="6428880"/>
                <a:ext cx="47520" cy="504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1985760" y="6399000"/>
                <a:ext cx="47520" cy="504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1985760" y="6419520"/>
                <a:ext cx="47520" cy="489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1033200" y="6098760"/>
                <a:ext cx="47520" cy="504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1033200" y="6119280"/>
                <a:ext cx="47520" cy="489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1033200" y="6089400"/>
                <a:ext cx="47520" cy="504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1033200" y="6089400"/>
                <a:ext cx="47520" cy="5040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509400" y="789912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1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509400" y="741960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1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509400" y="694008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2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509400" y="646056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2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509400" y="598140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3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509400" y="550224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3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747360" y="812772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1699920" y="812772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2652480" y="812772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3614400" y="812772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4566960" y="812772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5519520" y="812772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1" name=""/>
            <p:cNvGrpSpPr/>
            <p:nvPr/>
          </p:nvGrpSpPr>
          <p:grpSpPr>
            <a:xfrm>
              <a:off x="509400" y="971280"/>
              <a:ext cx="5081760" cy="2809080"/>
              <a:chOff x="509400" y="971280"/>
              <a:chExt cx="5081760" cy="2809080"/>
            </a:xfrm>
          </p:grpSpPr>
          <p:sp>
            <p:nvSpPr>
              <p:cNvPr id="102" name=""/>
              <p:cNvSpPr/>
              <p:nvPr/>
            </p:nvSpPr>
            <p:spPr>
              <a:xfrm>
                <a:off x="776160" y="2987280"/>
                <a:ext cx="4762440" cy="1440"/>
              </a:xfrm>
              <a:prstGeom prst="line">
                <a:avLst/>
              </a:prstGeom>
              <a:ln w="0">
                <a:solidFill>
                  <a:srgbClr val="c0c0c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776160" y="2507760"/>
                <a:ext cx="4762440" cy="1800"/>
              </a:xfrm>
              <a:prstGeom prst="line">
                <a:avLst/>
              </a:prstGeom>
              <a:ln w="0">
                <a:solidFill>
                  <a:srgbClr val="c0c0c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776160" y="2037960"/>
                <a:ext cx="4762440" cy="1440"/>
              </a:xfrm>
              <a:prstGeom prst="line">
                <a:avLst/>
              </a:prstGeom>
              <a:ln w="0">
                <a:solidFill>
                  <a:srgbClr val="c0c0c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1061640" y="1837800"/>
                <a:ext cx="3810240" cy="1208160"/>
              </a:xfrm>
              <a:custGeom>
                <a:avLst/>
                <a:gdLst/>
                <a:ahLst/>
                <a:rect l="l" t="t" r="r" b="b"/>
                <a:pathLst>
                  <a:path w="400" h="121">
                    <a:moveTo>
                      <a:pt x="0" y="0"/>
                    </a:moveTo>
                    <a:lnTo>
                      <a:pt x="21" y="7"/>
                    </a:lnTo>
                    <a:lnTo>
                      <a:pt x="42" y="13"/>
                    </a:lnTo>
                    <a:lnTo>
                      <a:pt x="63" y="20"/>
                    </a:lnTo>
                    <a:lnTo>
                      <a:pt x="84" y="26"/>
                    </a:lnTo>
                    <a:lnTo>
                      <a:pt x="105" y="32"/>
                    </a:lnTo>
                    <a:lnTo>
                      <a:pt x="126" y="39"/>
                    </a:lnTo>
                    <a:lnTo>
                      <a:pt x="147" y="45"/>
                    </a:lnTo>
                    <a:lnTo>
                      <a:pt x="169" y="51"/>
                    </a:lnTo>
                    <a:lnTo>
                      <a:pt x="190" y="58"/>
                    </a:lnTo>
                    <a:lnTo>
                      <a:pt x="211" y="64"/>
                    </a:lnTo>
                    <a:lnTo>
                      <a:pt x="232" y="70"/>
                    </a:lnTo>
                    <a:lnTo>
                      <a:pt x="253" y="77"/>
                    </a:lnTo>
                    <a:lnTo>
                      <a:pt x="274" y="83"/>
                    </a:lnTo>
                    <a:lnTo>
                      <a:pt x="295" y="89"/>
                    </a:lnTo>
                    <a:lnTo>
                      <a:pt x="316" y="96"/>
                    </a:lnTo>
                    <a:lnTo>
                      <a:pt x="337" y="102"/>
                    </a:lnTo>
                    <a:lnTo>
                      <a:pt x="358" y="109"/>
                    </a:lnTo>
                    <a:lnTo>
                      <a:pt x="379" y="115"/>
                    </a:lnTo>
                    <a:lnTo>
                      <a:pt x="400" y="121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776160" y="1558440"/>
                <a:ext cx="4762440" cy="1800"/>
              </a:xfrm>
              <a:prstGeom prst="line">
                <a:avLst/>
              </a:prstGeom>
              <a:ln w="0">
                <a:solidFill>
                  <a:srgbClr val="c0c0c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776160" y="1088640"/>
                <a:ext cx="4762440" cy="1440"/>
              </a:xfrm>
              <a:prstGeom prst="line">
                <a:avLst/>
              </a:prstGeom>
              <a:ln w="0">
                <a:solidFill>
                  <a:srgbClr val="c0c0c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776160" y="1088640"/>
                <a:ext cx="4762440" cy="2367000"/>
              </a:xfrm>
              <a:prstGeom prst="rect">
                <a:avLst/>
              </a:prstGeom>
              <a:noFill/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776160" y="1088640"/>
                <a:ext cx="1440" cy="23670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738000" y="3455640"/>
                <a:ext cx="3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738000" y="2987280"/>
                <a:ext cx="3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738000" y="2507760"/>
                <a:ext cx="381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738000" y="2037960"/>
                <a:ext cx="3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738000" y="1558440"/>
                <a:ext cx="3816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738000" y="1088640"/>
                <a:ext cx="381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776160" y="3455640"/>
                <a:ext cx="47624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 flipV="1">
                <a:off x="776160" y="3455640"/>
                <a:ext cx="1440" cy="41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 flipV="1">
                <a:off x="1728360" y="3455640"/>
                <a:ext cx="1800" cy="41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 flipV="1">
                <a:off x="2680920" y="3455640"/>
                <a:ext cx="1800" cy="41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 flipV="1">
                <a:off x="3633480" y="3455640"/>
                <a:ext cx="1800" cy="41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 flipV="1">
                <a:off x="4586040" y="3455640"/>
                <a:ext cx="1440" cy="41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 flipV="1">
                <a:off x="5538600" y="3455640"/>
                <a:ext cx="1440" cy="41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4843080" y="2966760"/>
                <a:ext cx="47880" cy="507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4843080" y="2966760"/>
                <a:ext cx="47880" cy="507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4843080" y="2966760"/>
                <a:ext cx="47880" cy="507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4843080" y="2976120"/>
                <a:ext cx="47880" cy="507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3890520" y="2757240"/>
                <a:ext cx="47880" cy="489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3890520" y="2766600"/>
                <a:ext cx="47880" cy="507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3890520" y="2747520"/>
                <a:ext cx="47880" cy="493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3890520" y="2787120"/>
                <a:ext cx="47880" cy="493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2938320" y="2436480"/>
                <a:ext cx="47520" cy="507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2938320" y="2417400"/>
                <a:ext cx="47520" cy="493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2938320" y="2436480"/>
                <a:ext cx="47520" cy="507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2938320" y="2466720"/>
                <a:ext cx="47520" cy="507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1985760" y="2117160"/>
                <a:ext cx="47520" cy="511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1985760" y="2107800"/>
                <a:ext cx="47520" cy="493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1985760" y="2117160"/>
                <a:ext cx="47520" cy="511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1985760" y="2107800"/>
                <a:ext cx="47520" cy="493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1033200" y="1787040"/>
                <a:ext cx="47520" cy="507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1033200" y="1777680"/>
                <a:ext cx="47520" cy="507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1033200" y="1798200"/>
                <a:ext cx="47520" cy="4932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1033200" y="1787040"/>
                <a:ext cx="47520" cy="5076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509400" y="333828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1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509400" y="286812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1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509400" y="238896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2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509400" y="191880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2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509400" y="143928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3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509400" y="971280"/>
                <a:ext cx="162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3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747360" y="356688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1699920" y="356688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2652480" y="356688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3605040" y="356688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4557240" y="356688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5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5509800" y="3566880"/>
                <a:ext cx="8136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 Narrow"/>
                  </a:rPr>
                  <a:t>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5" name=""/>
            <p:cNvSpPr/>
            <p:nvPr/>
          </p:nvSpPr>
          <p:spPr>
            <a:xfrm rot="16200000">
              <a:off x="-261000" y="2165400"/>
              <a:ext cx="1053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Arial Narrow"/>
                </a:rPr>
                <a:t>Threshold Cycl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rot="16200000">
              <a:off x="-261000" y="6720120"/>
              <a:ext cx="1053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Arial Narrow"/>
                </a:rPr>
                <a:t>Threshold Cycl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017440" y="8397720"/>
              <a:ext cx="22820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400" spc="-1" strike="noStrike">
                  <a:solidFill>
                    <a:srgbClr val="000000"/>
                  </a:solidFill>
                  <a:latin typeface="Arial Narrow"/>
                </a:rPr>
                <a:t>Log Starting Quantity, pg total RN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1-13T10:17:45Z</dcterms:created>
  <dc:creator>.</dc:creator>
  <dc:description/>
  <dc:language>en-US</dc:language>
  <cp:lastModifiedBy>.</cp:lastModifiedBy>
  <dcterms:modified xsi:type="dcterms:W3CDTF">2007-08-07T08:28:32Z</dcterms:modified>
  <cp:revision>5</cp:revision>
  <dc:subject/>
  <dc:title>Diapositiva 1</dc:title>
</cp:coreProperties>
</file>